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571301-328E-49C9-8148-988B9B827E79}" v="3" dt="2022-12-17T17:13:08.2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62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Xiang,Jenny Jing" userId="c0b1da7b-7211-47b3-b357-9d3cb7ffc9fa" providerId="ADAL" clId="{39571301-328E-49C9-8148-988B9B827E79}"/>
    <pc:docChg chg="custSel modSld modMainMaster">
      <pc:chgData name="Xiang,Jenny Jing" userId="c0b1da7b-7211-47b3-b357-9d3cb7ffc9fa" providerId="ADAL" clId="{39571301-328E-49C9-8148-988B9B827E79}" dt="2022-12-17T17:13:25.292" v="11" actId="120"/>
      <pc:docMkLst>
        <pc:docMk/>
      </pc:docMkLst>
      <pc:sldChg chg="modSp">
        <pc:chgData name="Xiang,Jenny Jing" userId="c0b1da7b-7211-47b3-b357-9d3cb7ffc9fa" providerId="ADAL" clId="{39571301-328E-49C9-8148-988B9B827E79}" dt="2022-12-17T17:13:08.285" v="2"/>
        <pc:sldMkLst>
          <pc:docMk/>
          <pc:sldMk cId="2212285662" sldId="256"/>
        </pc:sldMkLst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k cId="2212285662" sldId="256"/>
            <ac:spMk id="4" creationId="{A1163910-652B-C5DA-A66F-D09080801DF9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k cId="2212285662" sldId="256"/>
            <ac:spMk id="5" creationId="{E50EA77C-54AC-CC65-726E-71A4FE44ABDD}"/>
          </ac:spMkLst>
        </pc:spChg>
      </pc:sldChg>
      <pc:sldChg chg="modSp mod">
        <pc:chgData name="Xiang,Jenny Jing" userId="c0b1da7b-7211-47b3-b357-9d3cb7ffc9fa" providerId="ADAL" clId="{39571301-328E-49C9-8148-988B9B827E79}" dt="2022-12-17T17:13:08.357" v="3" actId="27636"/>
        <pc:sldMkLst>
          <pc:docMk/>
          <pc:sldMk cId="36161170" sldId="257"/>
        </pc:sldMkLst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k cId="36161170" sldId="257"/>
            <ac:spMk id="4" creationId="{BF87368B-0A96-2488-3937-D0C2D6B0EB27}"/>
          </ac:spMkLst>
        </pc:spChg>
        <pc:spChg chg="mod">
          <ac:chgData name="Xiang,Jenny Jing" userId="c0b1da7b-7211-47b3-b357-9d3cb7ffc9fa" providerId="ADAL" clId="{39571301-328E-49C9-8148-988B9B827E79}" dt="2022-12-17T17:13:08.357" v="3" actId="27636"/>
          <ac:spMkLst>
            <pc:docMk/>
            <pc:sldMk cId="36161170" sldId="257"/>
            <ac:spMk id="5" creationId="{3F33447B-5C04-4868-C4D5-1BE14966BFA4}"/>
          </ac:spMkLst>
        </pc:spChg>
      </pc:sldChg>
      <pc:sldChg chg="modSp mod">
        <pc:chgData name="Xiang,Jenny Jing" userId="c0b1da7b-7211-47b3-b357-9d3cb7ffc9fa" providerId="ADAL" clId="{39571301-328E-49C9-8148-988B9B827E79}" dt="2022-12-17T17:13:08.359" v="4" actId="27636"/>
        <pc:sldMkLst>
          <pc:docMk/>
          <pc:sldMk cId="384640850" sldId="258"/>
        </pc:sldMkLst>
        <pc:spChg chg="mod">
          <ac:chgData name="Xiang,Jenny Jing" userId="c0b1da7b-7211-47b3-b357-9d3cb7ffc9fa" providerId="ADAL" clId="{39571301-328E-49C9-8148-988B9B827E79}" dt="2022-12-17T17:13:08.359" v="4" actId="27636"/>
          <ac:spMkLst>
            <pc:docMk/>
            <pc:sldMk cId="384640850" sldId="258"/>
            <ac:spMk id="2" creationId="{8B2EEE61-B76E-26E4-905E-66F6ED123188}"/>
          </ac:spMkLst>
        </pc:spChg>
      </pc:sldChg>
      <pc:sldChg chg="modSp mod">
        <pc:chgData name="Xiang,Jenny Jing" userId="c0b1da7b-7211-47b3-b357-9d3cb7ffc9fa" providerId="ADAL" clId="{39571301-328E-49C9-8148-988B9B827E79}" dt="2022-12-17T17:13:08.360" v="5" actId="27636"/>
        <pc:sldMkLst>
          <pc:docMk/>
          <pc:sldMk cId="1951814934" sldId="259"/>
        </pc:sldMkLst>
        <pc:spChg chg="mod">
          <ac:chgData name="Xiang,Jenny Jing" userId="c0b1da7b-7211-47b3-b357-9d3cb7ffc9fa" providerId="ADAL" clId="{39571301-328E-49C9-8148-988B9B827E79}" dt="2022-12-17T17:13:08.360" v="5" actId="27636"/>
          <ac:spMkLst>
            <pc:docMk/>
            <pc:sldMk cId="1951814934" sldId="259"/>
            <ac:spMk id="2" creationId="{FCFACA93-E2FD-3FDC-DA68-4425540DD8D7}"/>
          </ac:spMkLst>
        </pc:spChg>
      </pc:sldChg>
      <pc:sldChg chg="modSp mod">
        <pc:chgData name="Xiang,Jenny Jing" userId="c0b1da7b-7211-47b3-b357-9d3cb7ffc9fa" providerId="ADAL" clId="{39571301-328E-49C9-8148-988B9B827E79}" dt="2022-12-17T17:13:08.362" v="6" actId="27636"/>
        <pc:sldMkLst>
          <pc:docMk/>
          <pc:sldMk cId="2879284482" sldId="260"/>
        </pc:sldMkLst>
        <pc:spChg chg="mod">
          <ac:chgData name="Xiang,Jenny Jing" userId="c0b1da7b-7211-47b3-b357-9d3cb7ffc9fa" providerId="ADAL" clId="{39571301-328E-49C9-8148-988B9B827E79}" dt="2022-12-17T17:13:08.362" v="6" actId="27636"/>
          <ac:spMkLst>
            <pc:docMk/>
            <pc:sldMk cId="2879284482" sldId="260"/>
            <ac:spMk id="2" creationId="{42519726-6788-07E3-3975-200B9D2AA8B0}"/>
          </ac:spMkLst>
        </pc:spChg>
      </pc:sldChg>
      <pc:sldChg chg="modSp mod">
        <pc:chgData name="Xiang,Jenny Jing" userId="c0b1da7b-7211-47b3-b357-9d3cb7ffc9fa" providerId="ADAL" clId="{39571301-328E-49C9-8148-988B9B827E79}" dt="2022-12-17T17:13:25.292" v="11" actId="120"/>
        <pc:sldMkLst>
          <pc:docMk/>
          <pc:sldMk cId="3504898957" sldId="261"/>
        </pc:sldMkLst>
        <pc:spChg chg="mod">
          <ac:chgData name="Xiang,Jenny Jing" userId="c0b1da7b-7211-47b3-b357-9d3cb7ffc9fa" providerId="ADAL" clId="{39571301-328E-49C9-8148-988B9B827E79}" dt="2022-12-17T17:13:25.292" v="11" actId="120"/>
          <ac:spMkLst>
            <pc:docMk/>
            <pc:sldMk cId="3504898957" sldId="261"/>
            <ac:spMk id="3" creationId="{4B1C80CA-E2FF-A4A4-82E5-57677A11A814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k cId="3504898957" sldId="261"/>
            <ac:spMk id="15" creationId="{38CAC6C8-E16F-9373-DECA-B363E0367AFE}"/>
          </ac:spMkLst>
        </pc:sp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4" creationId="{195221E7-2F27-652C-9746-91A89CC69E3D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5" creationId="{AC60E9A6-0A70-8222-87E8-06A537C2799B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6" creationId="{71AC0F8C-AF1C-DDD6-BAE0-DDBBE7E3544C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7" creationId="{D9DDB608-8370-A866-200C-6D62252DB056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8" creationId="{37A139AC-8DC4-2FE1-F067-F17AF55BD292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14" creationId="{0871949A-E4B3-BD25-2933-911F001221DA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16" creationId="{35C9F199-8B9A-6995-6402-96A0EB4D512B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19" creationId="{44DB93DA-7476-87A5-34E6-0E648CDAF996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20" creationId="{AD98041D-47FF-7C50-6880-986B5EF7DB26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23" creationId="{15C042EC-90B2-3F7C-2E43-7AC65BCD4D0B}"/>
          </ac:cxnSpMkLst>
        </pc:cxnChg>
        <pc:cxnChg chg="mod">
          <ac:chgData name="Xiang,Jenny Jing" userId="c0b1da7b-7211-47b3-b357-9d3cb7ffc9fa" providerId="ADAL" clId="{39571301-328E-49C9-8148-988B9B827E79}" dt="2022-12-17T17:13:08.285" v="2"/>
          <ac:cxnSpMkLst>
            <pc:docMk/>
            <pc:sldMk cId="3504898957" sldId="261"/>
            <ac:cxnSpMk id="24" creationId="{95628467-30E8-A6B1-D581-5986065E4AE1}"/>
          </ac:cxnSpMkLst>
        </pc:cxnChg>
      </pc:sldChg>
      <pc:sldChg chg="modSp mod">
        <pc:chgData name="Xiang,Jenny Jing" userId="c0b1da7b-7211-47b3-b357-9d3cb7ffc9fa" providerId="ADAL" clId="{39571301-328E-49C9-8148-988B9B827E79}" dt="2022-12-17T17:13:08.364" v="7" actId="27636"/>
        <pc:sldMkLst>
          <pc:docMk/>
          <pc:sldMk cId="3815378989" sldId="262"/>
        </pc:sldMkLst>
        <pc:spChg chg="mod">
          <ac:chgData name="Xiang,Jenny Jing" userId="c0b1da7b-7211-47b3-b357-9d3cb7ffc9fa" providerId="ADAL" clId="{39571301-328E-49C9-8148-988B9B827E79}" dt="2022-12-17T17:13:08.364" v="7" actId="27636"/>
          <ac:spMkLst>
            <pc:docMk/>
            <pc:sldMk cId="3815378989" sldId="262"/>
            <ac:spMk id="2" creationId="{EC62A391-534C-28D6-1A7C-D9EB6906E3D0}"/>
          </ac:spMkLst>
        </pc:spChg>
      </pc:sldChg>
      <pc:sldChg chg="modSp mod">
        <pc:chgData name="Xiang,Jenny Jing" userId="c0b1da7b-7211-47b3-b357-9d3cb7ffc9fa" providerId="ADAL" clId="{39571301-328E-49C9-8148-988B9B827E79}" dt="2022-12-17T17:13:08.367" v="8" actId="27636"/>
        <pc:sldMkLst>
          <pc:docMk/>
          <pc:sldMk cId="2758053569" sldId="263"/>
        </pc:sldMkLst>
        <pc:spChg chg="mod">
          <ac:chgData name="Xiang,Jenny Jing" userId="c0b1da7b-7211-47b3-b357-9d3cb7ffc9fa" providerId="ADAL" clId="{39571301-328E-49C9-8148-988B9B827E79}" dt="2022-12-17T17:13:08.367" v="8" actId="27636"/>
          <ac:spMkLst>
            <pc:docMk/>
            <pc:sldMk cId="2758053569" sldId="263"/>
            <ac:spMk id="2" creationId="{5FE70D93-12AA-92D8-0B82-7E3D356DE35C}"/>
          </ac:spMkLst>
        </pc:spChg>
        <pc:graphicFrameChg chg="mod">
          <ac:chgData name="Xiang,Jenny Jing" userId="c0b1da7b-7211-47b3-b357-9d3cb7ffc9fa" providerId="ADAL" clId="{39571301-328E-49C9-8148-988B9B827E79}" dt="2022-12-17T17:13:08.285" v="2"/>
          <ac:graphicFrameMkLst>
            <pc:docMk/>
            <pc:sldMk cId="2758053569" sldId="263"/>
            <ac:graphicFrameMk id="3" creationId="{C11690BD-E7A1-5771-D08B-FC3B041FC65E}"/>
          </ac:graphicFrameMkLst>
        </pc:graphicFrameChg>
      </pc:sldChg>
      <pc:sldChg chg="modSp mod">
        <pc:chgData name="Xiang,Jenny Jing" userId="c0b1da7b-7211-47b3-b357-9d3cb7ffc9fa" providerId="ADAL" clId="{39571301-328E-49C9-8148-988B9B827E79}" dt="2022-12-17T17:13:08.368" v="9" actId="27636"/>
        <pc:sldMkLst>
          <pc:docMk/>
          <pc:sldMk cId="2407273439" sldId="264"/>
        </pc:sldMkLst>
        <pc:spChg chg="mod">
          <ac:chgData name="Xiang,Jenny Jing" userId="c0b1da7b-7211-47b3-b357-9d3cb7ffc9fa" providerId="ADAL" clId="{39571301-328E-49C9-8148-988B9B827E79}" dt="2022-12-17T17:13:08.368" v="9" actId="27636"/>
          <ac:spMkLst>
            <pc:docMk/>
            <pc:sldMk cId="2407273439" sldId="264"/>
            <ac:spMk id="2" creationId="{5FFD787A-5FD1-B42C-1E73-B24CF0881267}"/>
          </ac:spMkLst>
        </pc:spChg>
        <pc:graphicFrameChg chg="mod">
          <ac:chgData name="Xiang,Jenny Jing" userId="c0b1da7b-7211-47b3-b357-9d3cb7ffc9fa" providerId="ADAL" clId="{39571301-328E-49C9-8148-988B9B827E79}" dt="2022-12-17T17:13:08.285" v="2"/>
          <ac:graphicFrameMkLst>
            <pc:docMk/>
            <pc:sldMk cId="2407273439" sldId="264"/>
            <ac:graphicFrameMk id="3" creationId="{8437D7DC-B09B-BE49-7006-E2AAB358B88E}"/>
          </ac:graphicFrameMkLst>
        </pc:graphicFrameChg>
      </pc:sldChg>
      <pc:sldChg chg="modSp mod">
        <pc:chgData name="Xiang,Jenny Jing" userId="c0b1da7b-7211-47b3-b357-9d3cb7ffc9fa" providerId="ADAL" clId="{39571301-328E-49C9-8148-988B9B827E79}" dt="2022-12-17T17:13:08.369" v="10" actId="27636"/>
        <pc:sldMkLst>
          <pc:docMk/>
          <pc:sldMk cId="215465207" sldId="265"/>
        </pc:sldMkLst>
        <pc:spChg chg="mod">
          <ac:chgData name="Xiang,Jenny Jing" userId="c0b1da7b-7211-47b3-b357-9d3cb7ffc9fa" providerId="ADAL" clId="{39571301-328E-49C9-8148-988B9B827E79}" dt="2022-12-17T17:13:08.369" v="10" actId="27636"/>
          <ac:spMkLst>
            <pc:docMk/>
            <pc:sldMk cId="215465207" sldId="265"/>
            <ac:spMk id="2" creationId="{50208A39-BFFF-FBE3-6679-E683BBD7F364}"/>
          </ac:spMkLst>
        </pc:spChg>
      </pc:sldChg>
      <pc:sldChg chg="modSp">
        <pc:chgData name="Xiang,Jenny Jing" userId="c0b1da7b-7211-47b3-b357-9d3cb7ffc9fa" providerId="ADAL" clId="{39571301-328E-49C9-8148-988B9B827E79}" dt="2022-12-17T17:13:08.285" v="2"/>
        <pc:sldMkLst>
          <pc:docMk/>
          <pc:sldMk cId="3466477852" sldId="266"/>
        </pc:sldMkLst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k cId="3466477852" sldId="266"/>
            <ac:spMk id="2" creationId="{C7847D5E-38C7-B71B-8253-4B1AAA53A48B}"/>
          </ac:spMkLst>
        </pc:spChg>
      </pc:sldChg>
      <pc:sldMasterChg chg="modSp modSldLayout">
        <pc:chgData name="Xiang,Jenny Jing" userId="c0b1da7b-7211-47b3-b357-9d3cb7ffc9fa" providerId="ADAL" clId="{39571301-328E-49C9-8148-988B9B827E79}" dt="2022-12-17T17:13:08.285" v="2"/>
        <pc:sldMasterMkLst>
          <pc:docMk/>
          <pc:sldMasterMk cId="3384379603" sldId="2147483648"/>
        </pc:sldMasterMkLst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asterMk cId="3384379603" sldId="2147483648"/>
            <ac:spMk id="2" creationId="{FA3E8299-A3D5-FA9D-FCC1-C76CAED92775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asterMk cId="3384379603" sldId="2147483648"/>
            <ac:spMk id="3" creationId="{F99CDB99-83DA-7DC3-AEC2-ABDF3D5383A4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asterMk cId="3384379603" sldId="2147483648"/>
            <ac:spMk id="4" creationId="{2863B220-17AB-A0F4-C660-9985EBC9057F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asterMk cId="3384379603" sldId="2147483648"/>
            <ac:spMk id="5" creationId="{832D8666-2752-DDD2-8376-1D7E0608388F}"/>
          </ac:spMkLst>
        </pc:spChg>
        <pc:spChg chg="mod">
          <ac:chgData name="Xiang,Jenny Jing" userId="c0b1da7b-7211-47b3-b357-9d3cb7ffc9fa" providerId="ADAL" clId="{39571301-328E-49C9-8148-988B9B827E79}" dt="2022-12-17T17:13:08.285" v="2"/>
          <ac:spMkLst>
            <pc:docMk/>
            <pc:sldMasterMk cId="3384379603" sldId="2147483648"/>
            <ac:spMk id="6" creationId="{CD0FA7B3-93DA-24E7-4FC1-084409BF18F5}"/>
          </ac:spMkLst>
        </pc:sp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977788102" sldId="2147483649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977788102" sldId="2147483649"/>
              <ac:spMk id="2" creationId="{D6FB66FE-B46B-0A06-96A4-C65C2EE82665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977788102" sldId="2147483649"/>
              <ac:spMk id="3" creationId="{FE474B5D-20EE-76D4-EA2F-3FB025787BE9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3817689163" sldId="2147483651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3817689163" sldId="2147483651"/>
              <ac:spMk id="2" creationId="{EC563945-3BEF-EDCF-340F-0D16CFA32AE1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3817689163" sldId="2147483651"/>
              <ac:spMk id="3" creationId="{18E6AE0E-1CCE-3FD0-01E2-AD639C3D550D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702958816" sldId="2147483652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702958816" sldId="2147483652"/>
              <ac:spMk id="3" creationId="{D474ECD4-601C-4B9D-CFAA-D3913E753CE7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702958816" sldId="2147483652"/>
              <ac:spMk id="4" creationId="{BB66BABF-BBF8-71AE-663F-B84C9FB1CA82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2467820372" sldId="2147483653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467820372" sldId="2147483653"/>
              <ac:spMk id="2" creationId="{EE9556F1-C11D-BD8A-9393-EF2AB36480FB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467820372" sldId="2147483653"/>
              <ac:spMk id="3" creationId="{345BBC52-F6AA-A244-7950-632BA57BE287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467820372" sldId="2147483653"/>
              <ac:spMk id="4" creationId="{0465FC58-CB68-EC8F-19BA-E4F6FB10011D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467820372" sldId="2147483653"/>
              <ac:spMk id="5" creationId="{30C77032-FC24-DDD0-6EEE-5DCABD124A00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467820372" sldId="2147483653"/>
              <ac:spMk id="6" creationId="{8107624F-205F-50F2-889F-A7CAD7269A5E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2227411922" sldId="2147483656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227411922" sldId="2147483656"/>
              <ac:spMk id="2" creationId="{8CFCEAAD-899F-F011-DD26-31F9E2FA3020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227411922" sldId="2147483656"/>
              <ac:spMk id="3" creationId="{C1FF4F45-CBB3-BAC7-0F88-EA1624AB80B4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227411922" sldId="2147483656"/>
              <ac:spMk id="4" creationId="{1CE41554-E925-4628-D4B0-81C78AD682F2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2617351509" sldId="2147483657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617351509" sldId="2147483657"/>
              <ac:spMk id="2" creationId="{7BBFB68E-67BA-C5B1-ED75-4946510F8980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617351509" sldId="2147483657"/>
              <ac:spMk id="3" creationId="{AB0843EE-0647-82F1-EA7D-F03D017A07C4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2617351509" sldId="2147483657"/>
              <ac:spMk id="4" creationId="{01FBA29E-A989-CBFC-05C6-E3B2BA884DD6}"/>
            </ac:spMkLst>
          </pc:spChg>
        </pc:sldLayoutChg>
        <pc:sldLayoutChg chg="modSp">
          <pc:chgData name="Xiang,Jenny Jing" userId="c0b1da7b-7211-47b3-b357-9d3cb7ffc9fa" providerId="ADAL" clId="{39571301-328E-49C9-8148-988B9B827E79}" dt="2022-12-17T17:13:08.285" v="2"/>
          <pc:sldLayoutMkLst>
            <pc:docMk/>
            <pc:sldMasterMk cId="3384379603" sldId="2147483648"/>
            <pc:sldLayoutMk cId="3313348048" sldId="2147483659"/>
          </pc:sldLayoutMkLst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3313348048" sldId="2147483659"/>
              <ac:spMk id="2" creationId="{DCB9D2AE-4444-8770-9995-1BE001F81F5E}"/>
            </ac:spMkLst>
          </pc:spChg>
          <pc:spChg chg="mod">
            <ac:chgData name="Xiang,Jenny Jing" userId="c0b1da7b-7211-47b3-b357-9d3cb7ffc9fa" providerId="ADAL" clId="{39571301-328E-49C9-8148-988B9B827E79}" dt="2022-12-17T17:13:08.285" v="2"/>
            <ac:spMkLst>
              <pc:docMk/>
              <pc:sldMasterMk cId="3384379603" sldId="2147483648"/>
              <pc:sldLayoutMk cId="3313348048" sldId="2147483659"/>
              <ac:spMk id="3" creationId="{EEC3F115-17EF-CFD5-6C6A-765F8F777D18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81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15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29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9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084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302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03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37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668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019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9650B-E1FB-478C-94C0-371E53D3F1F9}" type="datetimeFigureOut">
              <a:rPr lang="en-US" smtClean="0"/>
              <a:t>1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8E9C3-7CB4-48D1-B71E-C840B0A77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81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9">
            <a:extLst>
              <a:ext uri="{FF2B5EF4-FFF2-40B4-BE49-F238E27FC236}">
                <a16:creationId xmlns:a16="http://schemas.microsoft.com/office/drawing/2014/main" id="{A1163910-652B-C5DA-A66F-D09080801DF9}"/>
              </a:ext>
            </a:extLst>
          </p:cNvPr>
          <p:cNvSpPr txBox="1">
            <a:spLocks/>
          </p:cNvSpPr>
          <p:nvPr/>
        </p:nvSpPr>
        <p:spPr>
          <a:xfrm>
            <a:off x="445770" y="3108960"/>
            <a:ext cx="8171470" cy="205740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1350" dirty="0"/>
              <a:t>Project Title</a:t>
            </a:r>
          </a:p>
          <a:p>
            <a:pPr marL="0" indent="0" algn="ctr">
              <a:buNone/>
            </a:pPr>
            <a:r>
              <a:rPr lang="en-US" sz="1350" dirty="0"/>
              <a:t>Team Members</a:t>
            </a:r>
          </a:p>
        </p:txBody>
      </p:sp>
      <p:sp>
        <p:nvSpPr>
          <p:cNvPr id="5" name="Title 2">
            <a:extLst>
              <a:ext uri="{FF2B5EF4-FFF2-40B4-BE49-F238E27FC236}">
                <a16:creationId xmlns:a16="http://schemas.microsoft.com/office/drawing/2014/main" id="{E50EA77C-54AC-CC65-726E-71A4FE44ABDD}"/>
              </a:ext>
            </a:extLst>
          </p:cNvPr>
          <p:cNvSpPr txBox="1">
            <a:spLocks/>
          </p:cNvSpPr>
          <p:nvPr/>
        </p:nvSpPr>
        <p:spPr>
          <a:xfrm>
            <a:off x="457200" y="2590927"/>
            <a:ext cx="8172147" cy="380873"/>
          </a:xfrm>
          <a:prstGeom prst="rect">
            <a:avLst/>
          </a:prstGeom>
        </p:spPr>
        <p:txBody>
          <a:bodyPr vert="horz" lIns="68580" tIns="34290" rIns="68580" bIns="34290" rtlCol="0" anchor="b">
            <a:normAutofit fontScale="90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000" dirty="0"/>
              <a:t>Work-in-Progress Presentation</a:t>
            </a:r>
          </a:p>
        </p:txBody>
      </p:sp>
    </p:spTree>
    <p:extLst>
      <p:ext uri="{BB962C8B-B14F-4D97-AF65-F5344CB8AC3E}">
        <p14:creationId xmlns:p14="http://schemas.microsoft.com/office/powerpoint/2010/main" val="22122856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50208A39-BFFF-FBE3-6679-E683BBD7F364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Next Steps 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2154652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47D5E-38C7-B71B-8253-4B1AAA53A48B}"/>
              </a:ext>
            </a:extLst>
          </p:cNvPr>
          <p:cNvSpPr txBox="1">
            <a:spLocks/>
          </p:cNvSpPr>
          <p:nvPr/>
        </p:nvSpPr>
        <p:spPr>
          <a:xfrm>
            <a:off x="457200" y="3143250"/>
            <a:ext cx="6131052" cy="528066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Questions/Comments?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34664778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1">
            <a:extLst>
              <a:ext uri="{FF2B5EF4-FFF2-40B4-BE49-F238E27FC236}">
                <a16:creationId xmlns:a16="http://schemas.microsoft.com/office/drawing/2014/main" id="{BF87368B-0A96-2488-3937-D0C2D6B0EB27}"/>
              </a:ext>
            </a:extLst>
          </p:cNvPr>
          <p:cNvSpPr txBox="1">
            <a:spLocks/>
          </p:cNvSpPr>
          <p:nvPr/>
        </p:nvSpPr>
        <p:spPr>
          <a:xfrm>
            <a:off x="451185" y="1714500"/>
            <a:ext cx="8121316" cy="3600450"/>
          </a:xfrm>
          <a:prstGeom prst="rect">
            <a:avLst/>
          </a:prstGeom>
        </p:spPr>
        <p:txBody>
          <a:bodyPr vert="horz" lIns="68580" tIns="34290" rIns="68580" bIns="3429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57175" indent="-257175"/>
            <a:r>
              <a:rPr lang="en-US" sz="2100"/>
              <a:t>Team Members</a:t>
            </a:r>
          </a:p>
          <a:p>
            <a:pPr marL="257175" indent="-257175"/>
            <a:r>
              <a:rPr lang="en-US" sz="2100"/>
              <a:t>Mentor</a:t>
            </a:r>
          </a:p>
          <a:p>
            <a:pPr marL="257175" indent="-257175"/>
            <a:r>
              <a:rPr lang="en-US" sz="2100"/>
              <a:t>Stakeholders </a:t>
            </a:r>
            <a:endParaRPr lang="en-US" sz="2100" dirty="0"/>
          </a:p>
        </p:txBody>
      </p:sp>
      <p:sp>
        <p:nvSpPr>
          <p:cNvPr id="5" name="Title 2">
            <a:extLst>
              <a:ext uri="{FF2B5EF4-FFF2-40B4-BE49-F238E27FC236}">
                <a16:creationId xmlns:a16="http://schemas.microsoft.com/office/drawing/2014/main" id="{3F33447B-5C04-4868-C4D5-1BE14966BFA4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QI Team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361611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8B2EEE61-B76E-26E4-905E-66F6ED123188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Background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3846408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FCFACA93-E2FD-3FDC-DA68-4425540DD8D7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Problem Statement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19518149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42519726-6788-07E3-3975-200B9D2AA8B0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Process Map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28792844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4B1C80CA-E2FF-A4A4-82E5-57677A11A814}"/>
              </a:ext>
            </a:extLst>
          </p:cNvPr>
          <p:cNvSpPr>
            <a:spLocks noGrp="1"/>
          </p:cNvSpPr>
          <p:nvPr/>
        </p:nvSpPr>
        <p:spPr>
          <a:xfrm>
            <a:off x="753087" y="837191"/>
            <a:ext cx="5525714" cy="776568"/>
          </a:xfrm>
          <a:prstGeom prst="rect">
            <a:avLst/>
          </a:prstGeom>
        </p:spPr>
        <p:txBody>
          <a:bodyPr vert="horz" lIns="68580" tIns="34290" rIns="68580" bIns="3429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000" dirty="0"/>
              <a:t>Fishbone diagram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95221E7-2F27-652C-9746-91A89CC69E3D}"/>
              </a:ext>
            </a:extLst>
          </p:cNvPr>
          <p:cNvCxnSpPr>
            <a:endCxn id="3" idx="1"/>
          </p:cNvCxnSpPr>
          <p:nvPr/>
        </p:nvCxnSpPr>
        <p:spPr>
          <a:xfrm>
            <a:off x="1562927" y="3691263"/>
            <a:ext cx="3809174" cy="305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AC60E9A6-0A70-8222-87E8-06A537C2799B}"/>
              </a:ext>
            </a:extLst>
          </p:cNvPr>
          <p:cNvCxnSpPr/>
          <p:nvPr/>
        </p:nvCxnSpPr>
        <p:spPr>
          <a:xfrm flipH="1">
            <a:off x="917950" y="3691263"/>
            <a:ext cx="644978" cy="165007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1AC0F8C-AF1C-DDD6-BAE0-DDBBE7E3544C}"/>
              </a:ext>
            </a:extLst>
          </p:cNvPr>
          <p:cNvCxnSpPr/>
          <p:nvPr/>
        </p:nvCxnSpPr>
        <p:spPr>
          <a:xfrm>
            <a:off x="705677" y="2022039"/>
            <a:ext cx="857250" cy="16692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9DDB608-8370-A866-200C-6D62252DB056}"/>
              </a:ext>
            </a:extLst>
          </p:cNvPr>
          <p:cNvCxnSpPr/>
          <p:nvPr/>
        </p:nvCxnSpPr>
        <p:spPr>
          <a:xfrm flipH="1">
            <a:off x="3657600" y="3714750"/>
            <a:ext cx="593451" cy="16357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7A139AC-8DC4-2FE1-F067-F17AF55BD292}"/>
              </a:ext>
            </a:extLst>
          </p:cNvPr>
          <p:cNvCxnSpPr/>
          <p:nvPr/>
        </p:nvCxnSpPr>
        <p:spPr>
          <a:xfrm>
            <a:off x="3389686" y="1934734"/>
            <a:ext cx="845004" cy="175653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871949A-E4B3-BD25-2933-911F001221DA}"/>
              </a:ext>
            </a:extLst>
          </p:cNvPr>
          <p:cNvCxnSpPr/>
          <p:nvPr/>
        </p:nvCxnSpPr>
        <p:spPr>
          <a:xfrm>
            <a:off x="743689" y="2100090"/>
            <a:ext cx="30107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Oval 14">
            <a:extLst>
              <a:ext uri="{FF2B5EF4-FFF2-40B4-BE49-F238E27FC236}">
                <a16:creationId xmlns:a16="http://schemas.microsoft.com/office/drawing/2014/main" id="{38CAC6C8-E16F-9373-DECA-B363E0367AFE}"/>
              </a:ext>
            </a:extLst>
          </p:cNvPr>
          <p:cNvSpPr/>
          <p:nvPr/>
        </p:nvSpPr>
        <p:spPr>
          <a:xfrm>
            <a:off x="5372100" y="2971800"/>
            <a:ext cx="1485900" cy="14859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algn="ctr" rtl="0" fontAlgn="base">
              <a:spcBef>
                <a:spcPct val="0"/>
              </a:spcBef>
              <a:spcAft>
                <a:spcPct val="0"/>
              </a:spcAft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1pPr>
            <a:lvl2pPr marL="457200" algn="ctr" rtl="0" fontAlgn="base">
              <a:spcBef>
                <a:spcPct val="0"/>
              </a:spcBef>
              <a:spcAft>
                <a:spcPct val="0"/>
              </a:spcAft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2pPr>
            <a:lvl3pPr marL="914400" algn="ctr" rtl="0" fontAlgn="base">
              <a:spcBef>
                <a:spcPct val="0"/>
              </a:spcBef>
              <a:spcAft>
                <a:spcPct val="0"/>
              </a:spcAft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3pPr>
            <a:lvl4pPr marL="1371600" algn="ctr" rtl="0" fontAlgn="base">
              <a:spcBef>
                <a:spcPct val="0"/>
              </a:spcBef>
              <a:spcAft>
                <a:spcPct val="0"/>
              </a:spcAft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4pPr>
            <a:lvl5pPr marL="1828800" algn="ctr" rtl="0" fontAlgn="base">
              <a:spcBef>
                <a:spcPct val="0"/>
              </a:spcBef>
              <a:spcAft>
                <a:spcPct val="0"/>
              </a:spcAft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5pPr>
            <a:lvl6pPr marL="2286000" algn="l" defTabSz="457200" rtl="0" eaLnBrk="1" latinLnBrk="0" hangingPunct="1"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6pPr>
            <a:lvl7pPr marL="2743200" algn="l" defTabSz="457200" rtl="0" eaLnBrk="1" latinLnBrk="0" hangingPunct="1"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7pPr>
            <a:lvl8pPr marL="3200400" algn="l" defTabSz="457200" rtl="0" eaLnBrk="1" latinLnBrk="0" hangingPunct="1"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8pPr>
            <a:lvl9pPr marL="3657600" algn="l" defTabSz="457200" rtl="0" eaLnBrk="1" latinLnBrk="0" hangingPunct="1">
              <a:defRPr sz="5800" kern="1200">
                <a:solidFill>
                  <a:schemeClr val="lt1"/>
                </a:solidFill>
                <a:latin typeface="+mn-lt"/>
                <a:ea typeface="+mn-ea"/>
                <a:cs typeface="+mn-cs"/>
                <a:sym typeface="Gill Sans" charset="0"/>
              </a:defRPr>
            </a:lvl9pPr>
          </a:lstStyle>
          <a:p>
            <a:pPr defTabSz="3429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350">
              <a:solidFill>
                <a:prstClr val="white"/>
              </a:solidFill>
              <a:latin typeface="Calibri" panose="020F0502020204030204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5C9F199-8B9A-6995-6402-96A0EB4D512B}"/>
              </a:ext>
            </a:extLst>
          </p:cNvPr>
          <p:cNvCxnSpPr/>
          <p:nvPr/>
        </p:nvCxnSpPr>
        <p:spPr>
          <a:xfrm>
            <a:off x="3756577" y="5086352"/>
            <a:ext cx="30107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4DB93DA-7476-87A5-34E6-0E648CDAF996}"/>
              </a:ext>
            </a:extLst>
          </p:cNvPr>
          <p:cNvCxnSpPr/>
          <p:nvPr/>
        </p:nvCxnSpPr>
        <p:spPr>
          <a:xfrm>
            <a:off x="3472839" y="2116608"/>
            <a:ext cx="30107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D98041D-47FF-7C50-6880-986B5EF7DB26}"/>
              </a:ext>
            </a:extLst>
          </p:cNvPr>
          <p:cNvCxnSpPr/>
          <p:nvPr/>
        </p:nvCxnSpPr>
        <p:spPr>
          <a:xfrm>
            <a:off x="1028700" y="5029200"/>
            <a:ext cx="30107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5C042EC-90B2-3F7C-2E43-7AC65BCD4D0B}"/>
              </a:ext>
            </a:extLst>
          </p:cNvPr>
          <p:cNvCxnSpPr/>
          <p:nvPr/>
        </p:nvCxnSpPr>
        <p:spPr>
          <a:xfrm flipH="1">
            <a:off x="2343150" y="3714750"/>
            <a:ext cx="593451" cy="16357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5628467-30E8-A6B1-D581-5986065E4AE1}"/>
              </a:ext>
            </a:extLst>
          </p:cNvPr>
          <p:cNvCxnSpPr/>
          <p:nvPr/>
        </p:nvCxnSpPr>
        <p:spPr>
          <a:xfrm>
            <a:off x="2457452" y="5086352"/>
            <a:ext cx="30107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48989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EC62A391-534C-28D6-1A7C-D9EB6906E3D0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Aim Statement</a:t>
            </a:r>
            <a:endParaRPr lang="en-US" sz="3300" dirty="0"/>
          </a:p>
        </p:txBody>
      </p:sp>
    </p:spTree>
    <p:extLst>
      <p:ext uri="{BB962C8B-B14F-4D97-AF65-F5344CB8AC3E}">
        <p14:creationId xmlns:p14="http://schemas.microsoft.com/office/powerpoint/2010/main" val="38153789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5FE70D93-12AA-92D8-0B82-7E3D356DE35C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Intervention Ideas </a:t>
            </a:r>
            <a:endParaRPr lang="en-US" sz="3300" dirty="0"/>
          </a:p>
        </p:txBody>
      </p:sp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C11690BD-E7A1-5771-D08B-FC3B041FC6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1228868"/>
              </p:ext>
            </p:extLst>
          </p:nvPr>
        </p:nvGraphicFramePr>
        <p:xfrm>
          <a:off x="516962" y="1885950"/>
          <a:ext cx="7886700" cy="3414312"/>
        </p:xfrm>
        <a:graphic>
          <a:graphicData uri="http://schemas.openxmlformats.org/drawingml/2006/table">
            <a:tbl>
              <a:tblPr/>
              <a:tblGrid>
                <a:gridCol w="2628900">
                  <a:extLst>
                    <a:ext uri="{9D8B030D-6E8A-4147-A177-3AD203B41FA5}">
                      <a16:colId xmlns:a16="http://schemas.microsoft.com/office/drawing/2014/main" val="1882428755"/>
                    </a:ext>
                  </a:extLst>
                </a:gridCol>
                <a:gridCol w="2628900">
                  <a:extLst>
                    <a:ext uri="{9D8B030D-6E8A-4147-A177-3AD203B41FA5}">
                      <a16:colId xmlns:a16="http://schemas.microsoft.com/office/drawing/2014/main" val="4009223878"/>
                    </a:ext>
                  </a:extLst>
                </a:gridCol>
                <a:gridCol w="2628900">
                  <a:extLst>
                    <a:ext uri="{9D8B030D-6E8A-4147-A177-3AD203B41FA5}">
                      <a16:colId xmlns:a16="http://schemas.microsoft.com/office/drawing/2014/main" val="1439060953"/>
                    </a:ext>
                  </a:extLst>
                </a:gridCol>
              </a:tblGrid>
              <a:tr h="1138104"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26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66518" marR="66518" marT="33259" marB="33259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26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Effort​</a:t>
                      </a:r>
                      <a:endParaRPr lang="en-US" sz="13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66518" marR="66518" marT="33259" marB="33259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26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Effort​</a:t>
                      </a:r>
                      <a:endParaRPr lang="en-US" sz="13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66518" marR="66518" marT="33259" marB="33259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70361"/>
                  </a:ext>
                </a:extLst>
              </a:tr>
              <a:tr h="1138104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26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Impact​</a:t>
                      </a:r>
                      <a:endParaRPr lang="en-US" sz="13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66518" marR="66518" marT="33259" marB="33259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3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66518" marR="66518" marT="33259" marB="33259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3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66518" marR="66518" marT="33259" marB="33259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9163715"/>
                  </a:ext>
                </a:extLst>
              </a:tr>
              <a:tr h="1138104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26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Impact​</a:t>
                      </a:r>
                      <a:endParaRPr lang="en-US" sz="13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66518" marR="66518" marT="33259" marB="33259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3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66518" marR="66518" marT="33259" marB="33259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3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66518" marR="66518" marT="33259" marB="33259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48222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580535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>
            <a:extLst>
              <a:ext uri="{FF2B5EF4-FFF2-40B4-BE49-F238E27FC236}">
                <a16:creationId xmlns:a16="http://schemas.microsoft.com/office/drawing/2014/main" id="{5FFD787A-5FD1-B42C-1E73-B24CF0881267}"/>
              </a:ext>
            </a:extLst>
          </p:cNvPr>
          <p:cNvSpPr txBox="1">
            <a:spLocks/>
          </p:cNvSpPr>
          <p:nvPr/>
        </p:nvSpPr>
        <p:spPr>
          <a:xfrm>
            <a:off x="451186" y="1207010"/>
            <a:ext cx="8121315" cy="380873"/>
          </a:xfrm>
          <a:prstGeom prst="rect">
            <a:avLst/>
          </a:prstGeom>
        </p:spPr>
        <p:txBody>
          <a:bodyPr>
            <a:normAutofit fontScale="7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300"/>
              <a:t>Data Collection Plan</a:t>
            </a:r>
            <a:endParaRPr lang="en-US" sz="3300" dirty="0"/>
          </a:p>
        </p:txBody>
      </p:sp>
      <p:graphicFrame>
        <p:nvGraphicFramePr>
          <p:cNvPr id="3" name="Content Placeholder 4">
            <a:extLst>
              <a:ext uri="{FF2B5EF4-FFF2-40B4-BE49-F238E27FC236}">
                <a16:creationId xmlns:a16="http://schemas.microsoft.com/office/drawing/2014/main" id="{8437D7DC-B09B-BE49-7006-E2AAB358B8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9067799"/>
              </p:ext>
            </p:extLst>
          </p:nvPr>
        </p:nvGraphicFramePr>
        <p:xfrm>
          <a:off x="451186" y="2228850"/>
          <a:ext cx="7886698" cy="20645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84735">
                  <a:extLst>
                    <a:ext uri="{9D8B030D-6E8A-4147-A177-3AD203B41FA5}">
                      <a16:colId xmlns:a16="http://schemas.microsoft.com/office/drawing/2014/main" val="928327248"/>
                    </a:ext>
                  </a:extLst>
                </a:gridCol>
                <a:gridCol w="1193382">
                  <a:extLst>
                    <a:ext uri="{9D8B030D-6E8A-4147-A177-3AD203B41FA5}">
                      <a16:colId xmlns:a16="http://schemas.microsoft.com/office/drawing/2014/main" val="777006643"/>
                    </a:ext>
                  </a:extLst>
                </a:gridCol>
                <a:gridCol w="1357688">
                  <a:extLst>
                    <a:ext uri="{9D8B030D-6E8A-4147-A177-3AD203B41FA5}">
                      <a16:colId xmlns:a16="http://schemas.microsoft.com/office/drawing/2014/main" val="951157733"/>
                    </a:ext>
                  </a:extLst>
                </a:gridCol>
                <a:gridCol w="899360">
                  <a:extLst>
                    <a:ext uri="{9D8B030D-6E8A-4147-A177-3AD203B41FA5}">
                      <a16:colId xmlns:a16="http://schemas.microsoft.com/office/drawing/2014/main" val="183737841"/>
                    </a:ext>
                  </a:extLst>
                </a:gridCol>
                <a:gridCol w="1115552">
                  <a:extLst>
                    <a:ext uri="{9D8B030D-6E8A-4147-A177-3AD203B41FA5}">
                      <a16:colId xmlns:a16="http://schemas.microsoft.com/office/drawing/2014/main" val="1544496959"/>
                    </a:ext>
                  </a:extLst>
                </a:gridCol>
                <a:gridCol w="1098257">
                  <a:extLst>
                    <a:ext uri="{9D8B030D-6E8A-4147-A177-3AD203B41FA5}">
                      <a16:colId xmlns:a16="http://schemas.microsoft.com/office/drawing/2014/main" val="2167398139"/>
                    </a:ext>
                  </a:extLst>
                </a:gridCol>
                <a:gridCol w="1037723">
                  <a:extLst>
                    <a:ext uri="{9D8B030D-6E8A-4147-A177-3AD203B41FA5}">
                      <a16:colId xmlns:a16="http://schemas.microsoft.com/office/drawing/2014/main" val="1766384293"/>
                    </a:ext>
                  </a:extLst>
                </a:gridCol>
              </a:tblGrid>
              <a:tr h="964406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Type of Measure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Measure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Operational Definition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Data Source​</a:t>
                      </a:r>
                      <a:endParaRPr lang="en-US" sz="1400" dirty="0">
                        <a:effectLst/>
                        <a:latin typeface="YaleNew" panose="02000602050000020003"/>
                      </a:endParaRPr>
                    </a:p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(Where will the data come from?)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Frequency(How often will it be collected?)​</a:t>
                      </a:r>
                      <a:endParaRPr lang="en-US" sz="1400" dirty="0">
                        <a:effectLst/>
                        <a:latin typeface="YaleNew" panose="02000602050000020003"/>
                      </a:endParaRPr>
                    </a:p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Method (How will it be collected)​</a:t>
                      </a:r>
                      <a:endParaRPr lang="en-US" sz="1400" dirty="0">
                        <a:effectLst/>
                        <a:latin typeface="YaleNew" panose="02000602050000020003"/>
                      </a:endParaRPr>
                    </a:p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Who will collect the data?​</a:t>
                      </a:r>
                      <a:endParaRPr lang="en-US" sz="1400" b="1" i="0" dirty="0">
                        <a:solidFill>
                          <a:srgbClr val="FFFFFF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068679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>
                          <a:effectLst/>
                          <a:latin typeface="YaleNew" panose="02000602050000020003"/>
                        </a:rPr>
                        <a:t>​Outcome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5871560"/>
                  </a:ext>
                </a:extLst>
              </a:tr>
              <a:tr h="435769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Process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4901275"/>
                  </a:ext>
                </a:extLst>
              </a:tr>
              <a:tr h="435769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Balancing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dirty="0">
                          <a:effectLst/>
                          <a:latin typeface="YaleNew" panose="02000602050000020003"/>
                        </a:rPr>
                        <a:t>​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YaleNew" panose="02000602050000020003"/>
                      </a:endParaRPr>
                    </a:p>
                  </a:txBody>
                  <a:tcPr marL="68580" marR="68580" marT="34290" marB="3429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937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7273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22</Words>
  <Application>Microsoft Office PowerPoint</Application>
  <PresentationFormat>On-screen Show (4:3)</PresentationFormat>
  <Paragraphs>5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Yale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ng, Jenny</dc:creator>
  <cp:lastModifiedBy>Xiang,Jenny Jing</cp:lastModifiedBy>
  <cp:revision>6</cp:revision>
  <dcterms:created xsi:type="dcterms:W3CDTF">2022-07-09T16:15:00Z</dcterms:created>
  <dcterms:modified xsi:type="dcterms:W3CDTF">2022-12-17T17:13:29Z</dcterms:modified>
</cp:coreProperties>
</file>